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1" d="100"/>
          <a:sy n="61" d="100"/>
        </p:scale>
        <p:origin x="1794" y="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A1F8D5-379F-4B39-A384-5736F828E178}" type="datetimeFigureOut">
              <a:rPr lang="it-IT" smtClean="0"/>
              <a:pPr/>
              <a:t>04/11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C8351-2EEE-4C03-B8DD-F74793B5AFDD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7479123"/>
              </p:ext>
            </p:extLst>
          </p:nvPr>
        </p:nvGraphicFramePr>
        <p:xfrm>
          <a:off x="134747" y="1691379"/>
          <a:ext cx="5400599" cy="5484035"/>
        </p:xfrm>
        <a:graphic>
          <a:graphicData uri="http://schemas.openxmlformats.org/drawingml/2006/table">
            <a:tbl>
              <a:tblPr/>
              <a:tblGrid>
                <a:gridCol w="592128"/>
                <a:gridCol w="420484"/>
                <a:gridCol w="3365386"/>
                <a:gridCol w="300765"/>
                <a:gridCol w="360918"/>
                <a:gridCol w="360918"/>
              </a:tblGrid>
              <a:tr h="10238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athway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egg description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ene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S 293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K2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2386">
                <a:tc rowSpan="18" gridSpan="2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eptidoglycan</a:t>
                      </a:r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biosynthesis</a:t>
                      </a:r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</a:p>
                  </a:txBody>
                  <a:tcPr marL="4697" marR="4697" marT="4697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8"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urein polymerase, putative, gt51B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ndecaprenyl-diphosphatase 1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bacA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-alanyl-D-alanine carboxypeptidase family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acA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eptidase S13, D-Ala-D-Ala carboxypeptidase C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acB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-alanine--D-alanine ligase 2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dl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enicillin-binding protein 3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tsI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embrane carboxypeptidase (Penicillin-binding protein)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rcB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enicillin-binding protein 2, putativ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rdA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nofunctional biosynthetic peptidoglycan transglycosyl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tgA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DP-N-acetylglucosamine 1-carboxyvinyltransfer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urA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DP-N-acetylenolpyruvoylglucosamin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reductas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urB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DP-N-acetylmuramate--L-alanin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ligas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urC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DP-N-acetylmuramoylalanine--D-glutamat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ligas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urD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DP-N-acetylmuramyl-tripeptid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synthetases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subfamily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ur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DP-N-acetylmuramoyl-tripeptide--D-alanyl-D-alanin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ligas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urF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9017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ndecaprenyldiphospho-muramoylpentapeptid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beta-N-acetylglucosaminyltransferas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urG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irulenc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factor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MVIN-lik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rotei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murJ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hospho-N-acetylmuramoyl-pentapeptide-transferas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urX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02386">
                <a:tc rowSpan="19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Lipopolysaccharide</a:t>
                      </a:r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biosynthesis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pid A</a:t>
                      </a:r>
                    </a:p>
                  </a:txBody>
                  <a:tcPr marL="4697" marR="4697" marT="4697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DP-2,3-diacylglucosamine hydrol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yl-[acyl-carrier-protein]--UDP-N-acetylglucosamine O-acyltransfer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xA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pid-A-disaccharide synth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xB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DP-3-O-[3-hydroxymyristoyl] N-acetylglucosamine deacetyl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xC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DP-3-O-[3-hydroxymyristoyl] glucosamine N-acyltransfer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xD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etraacyldisaccharide 4'-kin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xK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pid A biosynthesis lauroyl (Or palmitoleoyl) acyltransferase subfamily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xL1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Bacterial lipid A biosynthesis acyltransferase superfamily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xL2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re region</a:t>
                      </a:r>
                    </a:p>
                  </a:txBody>
                  <a:tcPr marL="4697" marR="4697" marT="4697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-deoxy-D-manno-octulosonic-acid transferase subfamily, putativ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waaA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popolysaccharide heptosyltransferase I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waaC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popolysaccharide heptosyltransferase II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waaF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lycosyl transferase, group 1 family protein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waaG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popolysaccharide core kin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waaP3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nusual Sugar</a:t>
                      </a:r>
                    </a:p>
                  </a:txBody>
                  <a:tcPr marL="4697" marR="4697" marT="4697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atase, YrbI family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oheptose isomer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mhA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-dehydro-3-deoxyphosphooctonate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ldolas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1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dsA-1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-deoxy-manno-octulosonate cytidylyltransfer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dsB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ugar isomerase, KpsF/GutQ family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psF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inase, pfkB family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fa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rowSpan="7" gridSpan="2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Biosynthesis of unsaturated fatty acids 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7"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yl-CoA thioester hydrolase, putativ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 dirty="0" err="1" smtClean="0">
                          <a:solidFill>
                            <a:srgbClr val="000000"/>
                          </a:solidFill>
                          <a:latin typeface="Calibri"/>
                        </a:rPr>
                        <a:t>yciA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-oxoacyl-(Acyl-carrier-protein) reduct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abG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Oxidoreductase, short chain dehydrogenase/reductase family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abG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-hydroxyacyl-CoA dehydrogenase / short chain enoyl-CoA hydrat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adB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-hydroxyacyl-CoA dehydrogenas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adB3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DSL-like lipase/acylhydrolase, putative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esA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yl-CoA thioesterase II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esB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37939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700" b="1" i="0" u="none" strike="noStrike" dirty="0" err="1" smtClean="0">
                          <a:solidFill>
                            <a:srgbClr val="000000"/>
                          </a:solidFill>
                          <a:latin typeface="Calibri"/>
                        </a:rPr>
                        <a:t>Phospholipid</a:t>
                      </a:r>
                      <a:r>
                        <a:rPr lang="it-IT" sz="7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hospholipid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system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substrate-binding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rotei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alC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02386">
                <a:tc rowSpan="3" gridSpan="2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 smtClean="0">
                          <a:solidFill>
                            <a:srgbClr val="000000"/>
                          </a:solidFill>
                          <a:latin typeface="Calibri"/>
                        </a:rPr>
                        <a:t>Lipopolysaccharide</a:t>
                      </a:r>
                      <a:r>
                        <a:rPr lang="it-IT" sz="7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popolysaccharide export system ATP-binding protein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tB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popolysaccharide export system permease protein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tF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02386">
                <a:tc gridSpan="2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popolysaccharide export system permease protein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tG</a:t>
                      </a:r>
                    </a:p>
                  </a:txBody>
                  <a:tcPr marL="4697" marR="4697" marT="46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697" marR="4697" marT="46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</a:tbl>
          </a:graphicData>
        </a:graphic>
      </p:graphicFrame>
      <p:sp>
        <p:nvSpPr>
          <p:cNvPr id="7" name="CasellaDiTesto 6"/>
          <p:cNvSpPr txBox="1"/>
          <p:nvPr/>
        </p:nvSpPr>
        <p:spPr>
          <a:xfrm>
            <a:off x="0" y="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Figure S1</a:t>
            </a:r>
            <a:endParaRPr lang="it-IT" b="1" dirty="0"/>
          </a:p>
        </p:txBody>
      </p:sp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5424155"/>
              </p:ext>
            </p:extLst>
          </p:nvPr>
        </p:nvGraphicFramePr>
        <p:xfrm>
          <a:off x="5621490" y="1692574"/>
          <a:ext cx="1360985" cy="581025"/>
        </p:xfrm>
        <a:graphic>
          <a:graphicData uri="http://schemas.openxmlformats.org/drawingml/2006/table">
            <a:tbl>
              <a:tblPr/>
              <a:tblGrid>
                <a:gridCol w="385003"/>
                <a:gridCol w="975982"/>
              </a:tblGrid>
              <a:tr h="97953"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igly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pregulated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9291"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pregulated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0628"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= equally regulate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966"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= downregulate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0931"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igly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downregulated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165069" y="7383989"/>
            <a:ext cx="5378152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Figure S1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Heatmap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 of the transcription level of genes involved in cellular wall and membrane biosynthesis. Yellow indicates the same level of transcription, light green indicates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upregulation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, dark green indicates strong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upregulation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, red indicates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downregulation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 and dark red indicates strong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downregulation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Figure S2</a:t>
            </a:r>
            <a:endParaRPr lang="it-IT" b="1" dirty="0"/>
          </a:p>
        </p:txBody>
      </p:sp>
      <p:graphicFrame>
        <p:nvGraphicFramePr>
          <p:cNvPr id="5" name="Tabel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0893416"/>
              </p:ext>
            </p:extLst>
          </p:nvPr>
        </p:nvGraphicFramePr>
        <p:xfrm>
          <a:off x="1197853" y="1869198"/>
          <a:ext cx="3800473" cy="3735996"/>
        </p:xfrm>
        <a:graphic>
          <a:graphicData uri="http://schemas.openxmlformats.org/drawingml/2006/table">
            <a:tbl>
              <a:tblPr/>
              <a:tblGrid>
                <a:gridCol w="454310"/>
                <a:gridCol w="2402940"/>
                <a:gridCol w="234501"/>
                <a:gridCol w="354361"/>
                <a:gridCol w="354361"/>
              </a:tblGrid>
              <a:tr h="138838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athway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Kegg</a:t>
                      </a:r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description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ene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KS 293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K2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6216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ate/Nitrite transport</a:t>
                      </a:r>
                    </a:p>
                  </a:txBody>
                  <a:tcPr marL="6849" marR="6849" marT="6849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lutamine synthetase, type I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lnA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II uridylyl-transferase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lnD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ate transporter ATPase NasD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sD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ate ABC transporter permease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rtB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ate transport ATP-binding protein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rtC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ensory box histidine kinase NtrB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ntrB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wo-component response regulator NtrC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trC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otransferase system, nitrogen regulatory IIA protein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tsN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13252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oenolpyruvate-protein phosphotransferase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tsP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26216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hospate</a:t>
                      </a:r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ate regulon transcriptional regulatory protein phoB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oB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ate regulon sensor protein PhoR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hoR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ate ABC transporter permease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stA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ate transporter ATP-binding protein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stB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3252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hosphat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ABC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er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eriplasmic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binding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rotei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stS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132527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e (</a:t>
                      </a: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II</a:t>
                      </a:r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 </a:t>
                      </a: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ptak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ron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III)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system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substrate-binding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rotei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fuA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3252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ron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III)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system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ermeas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rotei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fuB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3252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ron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III)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system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TP-binding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rotei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fuC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32527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ron</a:t>
                      </a:r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omplex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e3+-hydroxamate ABC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er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eriplasmic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binding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rotei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hu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3252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e3+-siderophore ABC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er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ermease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rotei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fhuB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3252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ron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omplex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port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system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TP-binding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rotei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fhuC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2621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hemotaxis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otein-glutamate methylesterase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heB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otein-glutamate methylesterase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heB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hemotaxis protein methyltransferase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heR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hemotaxis protein methyltransferase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heR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ype IV pili response regulator PilG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ilG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262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ype IV pili response regulator PilH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ilH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3252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methyl-accepting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hemotaxis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rotei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ilJ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6849" marR="6849" marT="684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32527">
                <a:tc vMerge="1">
                  <a:txBody>
                    <a:bodyPr/>
                    <a:lstStyle/>
                    <a:p>
                      <a:pPr algn="ctr" fontAlgn="ctr"/>
                      <a:endParaRPr lang="it-IT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b="0" i="0" u="none" strike="noStrike" dirty="0" err="1" smtClean="0">
                          <a:solidFill>
                            <a:srgbClr val="000000"/>
                          </a:solidFill>
                          <a:latin typeface="+mn-lt"/>
                        </a:rPr>
                        <a:t>TonB-dependent</a:t>
                      </a:r>
                      <a:r>
                        <a:rPr lang="it-IT" sz="7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 </a:t>
                      </a:r>
                      <a:r>
                        <a:rPr lang="it-IT" sz="700" b="0" i="0" u="none" strike="noStrike" dirty="0" err="1" smtClean="0">
                          <a:solidFill>
                            <a:srgbClr val="000000"/>
                          </a:solidFill>
                          <a:latin typeface="+mn-lt"/>
                        </a:rPr>
                        <a:t>receptor</a:t>
                      </a:r>
                      <a:r>
                        <a:rPr lang="it-IT" sz="7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 domain </a:t>
                      </a:r>
                      <a:r>
                        <a:rPr lang="it-IT" sz="700" b="0" i="0" u="none" strike="noStrike" dirty="0" err="1" smtClean="0">
                          <a:solidFill>
                            <a:srgbClr val="000000"/>
                          </a:solidFill>
                          <a:latin typeface="+mn-lt"/>
                        </a:rPr>
                        <a:t>protein</a:t>
                      </a:r>
                      <a:r>
                        <a:rPr lang="it-IT" sz="7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 </a:t>
                      </a:r>
                    </a:p>
                  </a:txBody>
                  <a:tcPr marL="6849" marR="6849" marT="684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700" b="0" i="1" u="none" strike="noStrike" dirty="0" err="1" smtClean="0">
                          <a:solidFill>
                            <a:srgbClr val="000000"/>
                          </a:solidFill>
                          <a:latin typeface="+mn-lt"/>
                        </a:rPr>
                        <a:t>ompS</a:t>
                      </a:r>
                      <a:endParaRPr lang="it-IT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9" marR="6849" marT="684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5711" marR="5711" marT="57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5711" marR="5711" marT="57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6" name="Tabel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1234923"/>
              </p:ext>
            </p:extLst>
          </p:nvPr>
        </p:nvGraphicFramePr>
        <p:xfrm>
          <a:off x="5068070" y="1874183"/>
          <a:ext cx="1360985" cy="581025"/>
        </p:xfrm>
        <a:graphic>
          <a:graphicData uri="http://schemas.openxmlformats.org/drawingml/2006/table">
            <a:tbl>
              <a:tblPr/>
              <a:tblGrid>
                <a:gridCol w="385003"/>
                <a:gridCol w="975982"/>
              </a:tblGrid>
              <a:tr h="97953"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igly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pregulated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9291"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pregulated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0628"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= equally regulate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966"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= downregulate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0931"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igly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downregulated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274051" y="5753407"/>
            <a:ext cx="3581400" cy="16619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Figure S2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Heatmap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 of the transcription level of genes involved in ions uptake and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chemotaxis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. Yellow indicates the same level of transcription, light green indicates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upregulation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, dark green indicates strong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upregulation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, red indicates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downregulation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 and dark red indicates strong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downregulation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.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810F80663EE4A48816184062C154F03" ma:contentTypeVersion="7" ma:contentTypeDescription="Create a new document." ma:contentTypeScope="" ma:versionID="63c4b1ff8eedc98cb272ca39befa7e13">
  <xsd:schema xmlns:xsd="http://www.w3.org/2001/XMLSchema" xmlns:p="http://schemas.microsoft.com/office/2006/metadata/properties" xmlns:ns2="1a6eac5b-2110-4d64-97e7-57d93c1cfa32" targetNamespace="http://schemas.microsoft.com/office/2006/metadata/properties" ma:root="true" ma:fieldsID="82579d65873cc083acf4514d27052f75" ns2:_="">
    <xsd:import namespace="1a6eac5b-2110-4d64-97e7-57d93c1cfa3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a6eac5b-2110-4d64-97e7-57d93c1cfa3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1a6eac5b-2110-4d64-97e7-57d93c1cfa32">
      <UserInfo>
        <DisplayName/>
        <AccountId xsi:nil="true"/>
        <AccountType/>
      </UserInfo>
    </Checked_x0020_Out_x0020_To>
    <DocumentId xmlns="1a6eac5b-2110-4d64-97e7-57d93c1cfa32">Presentation 1.PPTX</DocumentId>
    <TitleName xmlns="1a6eac5b-2110-4d64-97e7-57d93c1cfa32">Presentation 1.PPTX</TitleName>
    <IsDeleted xmlns="1a6eac5b-2110-4d64-97e7-57d93c1cfa32">false</IsDeleted>
    <FileFormat xmlns="1a6eac5b-2110-4d64-97e7-57d93c1cfa32">PPTX</FileFormat>
    <DocumentType xmlns="1a6eac5b-2110-4d64-97e7-57d93c1cfa32">Presentation</DocumentType>
    <StageName xmlns="1a6eac5b-2110-4d64-97e7-57d93c1cfa32" xsi:nil="true"/>
  </documentManagement>
</p:properties>
</file>

<file path=customXml/itemProps1.xml><?xml version="1.0" encoding="utf-8"?>
<ds:datastoreItem xmlns:ds="http://schemas.openxmlformats.org/officeDocument/2006/customXml" ds:itemID="{5B9ED9D3-1E17-4118-AEFC-68D4902CCFD6}"/>
</file>

<file path=customXml/itemProps2.xml><?xml version="1.0" encoding="utf-8"?>
<ds:datastoreItem xmlns:ds="http://schemas.openxmlformats.org/officeDocument/2006/customXml" ds:itemID="{D66B936B-2D05-4CF9-8736-A3C3646B14C2}"/>
</file>

<file path=customXml/itemProps3.xml><?xml version="1.0" encoding="utf-8"?>
<ds:datastoreItem xmlns:ds="http://schemas.openxmlformats.org/officeDocument/2006/customXml" ds:itemID="{1CBEE8C0-9171-4AB3-94C2-972002470210}"/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573</Words>
  <Application>Microsoft Office PowerPoint</Application>
  <PresentationFormat>A4 (21x29,7 cm)</PresentationFormat>
  <Paragraphs>341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Tema di Offic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artaB</dc:creator>
  <cp:lastModifiedBy>Utente</cp:lastModifiedBy>
  <cp:revision>5</cp:revision>
  <dcterms:created xsi:type="dcterms:W3CDTF">2016-08-02T09:42:54Z</dcterms:created>
  <dcterms:modified xsi:type="dcterms:W3CDTF">2016-11-04T11:34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810F80663EE4A48816184062C154F03</vt:lpwstr>
  </property>
</Properties>
</file>